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F2922-D296-4404-891D-8B23160FAF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12CAD-37F9-4D66-93DE-C1D80EB0EC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E2C66-7636-459C-82DA-DEBF05EA2D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54013-B1A8-4197-BC50-487964D4EB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3D4A1-B060-4F82-AB55-6B4D1A0219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6524F-7783-4B7F-97AB-3BE0C9E46C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06FDC-C776-402B-9976-36492CC5DB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9433E-4FC1-41EC-919E-E561679B92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46584-ADEF-40DC-A78E-CBC18DD20D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3C0E9-A877-4530-BCA7-D6CA974AC9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20F25-2258-44C6-8F82-C3AB4D3F9F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6AF3F-0237-44AC-B4FD-02CD083C85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B2ED8D-159D-45A5-BA9C-018E6CF276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2365200" y="1143000"/>
            <a:ext cx="4340160" cy="3720960"/>
            <a:chOff x="2365200" y="1143000"/>
            <a:chExt cx="4340160" cy="3720960"/>
          </a:xfrm>
        </p:grpSpPr>
        <p:sp>
          <p:nvSpPr>
            <p:cNvPr id="42" name="Text Box 5"/>
            <p:cNvSpPr/>
            <p:nvPr/>
          </p:nvSpPr>
          <p:spPr>
            <a:xfrm>
              <a:off x="3828960" y="454356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V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6"/>
            <p:cNvSpPr/>
            <p:nvPr/>
          </p:nvSpPr>
          <p:spPr>
            <a:xfrm>
              <a:off x="4435200" y="4525920"/>
              <a:ext cx="73188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7"/>
            <p:cNvSpPr/>
            <p:nvPr/>
          </p:nvSpPr>
          <p:spPr>
            <a:xfrm>
              <a:off x="5081400" y="4525920"/>
              <a:ext cx="82224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K17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8"/>
            <p:cNvSpPr/>
            <p:nvPr/>
          </p:nvSpPr>
          <p:spPr>
            <a:xfrm>
              <a:off x="5883120" y="4525920"/>
              <a:ext cx="82224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K18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9"/>
            <p:cNvSpPr/>
            <p:nvPr/>
          </p:nvSpPr>
          <p:spPr>
            <a:xfrm>
              <a:off x="3157200" y="419112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3828960" y="419112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4573440" y="419112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2"/>
            <p:cNvSpPr/>
            <p:nvPr/>
          </p:nvSpPr>
          <p:spPr>
            <a:xfrm>
              <a:off x="5263920" y="419112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3"/>
            <p:cNvSpPr/>
            <p:nvPr/>
          </p:nvSpPr>
          <p:spPr>
            <a:xfrm>
              <a:off x="5975280" y="419112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4"/>
            <p:cNvSpPr/>
            <p:nvPr/>
          </p:nvSpPr>
          <p:spPr>
            <a:xfrm>
              <a:off x="3157200" y="454356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15" descr="NFAT-AP1-LUC "/>
            <p:cNvPicPr/>
            <p:nvPr/>
          </p:nvPicPr>
          <p:blipFill>
            <a:blip r:embed="rId1"/>
            <a:stretch/>
          </p:blipFill>
          <p:spPr>
            <a:xfrm>
              <a:off x="2616120" y="1143000"/>
              <a:ext cx="3975120" cy="316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 Box 16"/>
            <p:cNvSpPr/>
            <p:nvPr/>
          </p:nvSpPr>
          <p:spPr>
            <a:xfrm>
              <a:off x="2365200" y="4191120"/>
              <a:ext cx="73188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FA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7"/>
            <p:cNvSpPr/>
            <p:nvPr/>
          </p:nvSpPr>
          <p:spPr>
            <a:xfrm>
              <a:off x="2384280" y="4525920"/>
              <a:ext cx="731880" cy="338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Foxp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8"/>
            <p:cNvSpPr/>
            <p:nvPr/>
          </p:nvSpPr>
          <p:spPr>
            <a:xfrm>
              <a:off x="4876560" y="1219320"/>
              <a:ext cx="167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FAT-AP1-LU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Text Box 20"/>
          <p:cNvSpPr/>
          <p:nvPr/>
        </p:nvSpPr>
        <p:spPr>
          <a:xfrm>
            <a:off x="1295280" y="5105520"/>
            <a:ext cx="60962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uppl. Fig.1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-  K17R and K18R did not inhibit the activity of NFAT1 on NFAT:AP-1 site. 293T cells were transfected with NFAP1-luciferase vector, NFAT1 and WT Foxp3 or K17R or K18R. Forty hours later, cells were stimulated with 1 mM ionomycin, 10 nM PMA, and 2 mM CaCl2 for 6 hours, dual luciferase activity was measured and results normalized to renilla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7T15:48:25Z</dcterms:created>
  <dc:creator>Yujie Liu</dc:creator>
  <dc:description/>
  <dc:language>en-US</dc:language>
  <cp:lastModifiedBy>Wayne Hancock</cp:lastModifiedBy>
  <dcterms:modified xsi:type="dcterms:W3CDTF">2011-10-26T15:35:54Z</dcterms:modified>
  <cp:revision>4</cp:revision>
  <dc:subject/>
  <dc:title>PowerPoint Presentation</dc:title>
</cp:coreProperties>
</file>